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embeddings/oleObject3.xlsx" ContentType="application/vnd.openxmlformats-officedocument.spreadsheetml.sheet"/>
  <Override PartName="/ppt/media/image1.wmf" ContentType="image/x-wmf"/>
  <Override PartName="/ppt/media/image2.wmf" ContentType="image/x-wmf"/>
  <Override PartName="/ppt/media/image3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927774-BD88-4DC7-BEC1-FB7EF294DFB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4A5C7E-C188-4EA1-9114-F9A38BAF068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1B1BC4-E4AB-4F43-8D31-DFF989748BF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084FAE-7279-433B-9175-5AAB809A345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FAB337-A132-4E75-B34B-93CAE453677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DA9D65-87B5-4AD9-B124-9B9BFA1B3AC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7A2824-BF9B-461D-9CF3-042387BB526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7EC102-D865-4CE2-9E4C-5D074C9A36F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D2AE0E-B13D-4D15-8AAD-2A96E11BAE4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FD8A6E-8C60-41D7-99A4-9C826FB6799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D548E9-98C6-4EC7-95C7-313CAF8F79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F64052-E8D6-4F09-A7B4-EB567A6A3BA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4F8AECD-457D-4ED2-A259-14E2C63AB8B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2.wmf"/><Relationship Id="rId5" Type="http://schemas.openxmlformats.org/officeDocument/2006/relationships/package" Target="../embeddings/oleObject3.xlsx"/><Relationship Id="rId6" Type="http://schemas.openxmlformats.org/officeDocument/2006/relationships/image" Target="../media/image3.wmf"/><Relationship Id="rId7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611280" y="333360"/>
            <a:ext cx="7826400" cy="2620800"/>
            <a:chOff x="611280" y="333360"/>
            <a:chExt cx="7826400" cy="2620800"/>
          </a:xfrm>
        </p:grpSpPr>
        <p:graphicFrame>
          <p:nvGraphicFramePr>
            <p:cNvPr id="42" name=""/>
            <p:cNvGraphicFramePr/>
            <p:nvPr/>
          </p:nvGraphicFramePr>
          <p:xfrm>
            <a:off x="611280" y="333360"/>
            <a:ext cx="2665440" cy="2620800"/>
          </p:xfrm>
          <a:graphic>
            <a:graphicData uri="http://schemas.openxmlformats.org/presentationml/2006/ole">
              <p:oleObj progId="Excel.Sheet.12" r:id="rId1" spid="">
                <p:embed/>
                <p:pic>
                  <p:nvPicPr>
                    <p:cNvPr id="43" name="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611280" y="333360"/>
                      <a:ext cx="2665440" cy="26208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44" name=""/>
            <p:cNvGraphicFramePr/>
            <p:nvPr/>
          </p:nvGraphicFramePr>
          <p:xfrm>
            <a:off x="3179880" y="333360"/>
            <a:ext cx="2665440" cy="2620800"/>
          </p:xfrm>
          <a:graphic>
            <a:graphicData uri="http://schemas.openxmlformats.org/presentationml/2006/ole">
              <p:oleObj progId="Excel.Sheet.12" r:id="rId3" spid="">
                <p:embed/>
                <p:pic>
                  <p:nvPicPr>
                    <p:cNvPr id="45" name="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3179880" y="333360"/>
                      <a:ext cx="2665440" cy="26208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46" name=""/>
            <p:cNvGraphicFramePr/>
            <p:nvPr/>
          </p:nvGraphicFramePr>
          <p:xfrm>
            <a:off x="5781600" y="333360"/>
            <a:ext cx="2656080" cy="2581200"/>
          </p:xfrm>
          <a:graphic>
            <a:graphicData uri="http://schemas.openxmlformats.org/presentationml/2006/ole">
              <p:oleObj progId="Excel.Sheet.12" r:id="rId5" spid="">
                <p:embed/>
                <p:pic>
                  <p:nvPicPr>
                    <p:cNvPr id="47" name="" descr=""/>
                    <p:cNvPicPr/>
                    <p:nvPr/>
                  </p:nvPicPr>
                  <p:blipFill>
                    <a:blip r:embed="rId6"/>
                    <a:stretch/>
                  </p:blipFill>
                  <p:spPr>
                    <a:xfrm>
                      <a:off x="5781600" y="333360"/>
                      <a:ext cx="2656080" cy="25812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48" name=""/>
            <p:cNvSpPr/>
            <p:nvPr/>
          </p:nvSpPr>
          <p:spPr>
            <a:xfrm>
              <a:off x="1142640" y="536400"/>
              <a:ext cx="3164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3814560" y="536400"/>
              <a:ext cx="3164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6429240" y="536400"/>
              <a:ext cx="326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1" name=""/>
          <p:cNvSpPr/>
          <p:nvPr/>
        </p:nvSpPr>
        <p:spPr>
          <a:xfrm>
            <a:off x="684360" y="2997360"/>
            <a:ext cx="7848360" cy="1387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Figure S4: Equivalence of PPIX quantitation in PC-3 cells by flow cytometry or extraction and photometric measurement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3x10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5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cells were incubated for 16 h with different 5-ALA concentrations in the presence of 10% FCS. PPIX content was either determined after extraction of the cell pellets with 100 µl the aqueous based solubilizer Solvable™ (PerkinElmer) and further 100-fold dilution with Solvable™ by fluorescence spectroscopy (A) or by flow cytometry (FL3 photomultiplier tube; 670 nm long pass filter) (B). The concentrations of the final dilutions were calculated from a standard curve obtained by dilution of purified PPIX in Solvable™. The median of the PPIX fluorescence of the strongest labeled cell fraction is indicated. Both measurements proved to be highly equivalent as demonstrated by a coefficient of determination (R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) close to 1 (C)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2" name=""/>
          <p:cNvGrpSpPr/>
          <p:nvPr/>
        </p:nvGrpSpPr>
        <p:grpSpPr>
          <a:xfrm>
            <a:off x="8443800" y="5084640"/>
            <a:ext cx="5716080" cy="1066680"/>
            <a:chOff x="8443800" y="5084640"/>
            <a:chExt cx="5716080" cy="1066680"/>
          </a:xfrm>
        </p:grpSpPr>
        <p:sp>
          <p:nvSpPr>
            <p:cNvPr id="53" name=""/>
            <p:cNvSpPr/>
            <p:nvPr/>
          </p:nvSpPr>
          <p:spPr>
            <a:xfrm>
              <a:off x="8443800" y="5084640"/>
              <a:ext cx="5716080" cy="106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5880" rIns="6588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3-29T17:03:16Z</dcterms:created>
  <dc:creator>Prof. W. Zimmermann</dc:creator>
  <dc:description/>
  <dc:language>en-US</dc:language>
  <cp:lastModifiedBy>Prof. W. Zimmermann</cp:lastModifiedBy>
  <dcterms:modified xsi:type="dcterms:W3CDTF">2011-05-12T11:39:54Z</dcterms:modified>
  <cp:revision>14</cp:revision>
  <dc:subject/>
  <dc:title>Folie 1</dc:title>
</cp:coreProperties>
</file>